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4"/>
  </p:sldMasterIdLst>
  <p:sldIdLst>
    <p:sldId id="277" r:id="rId5"/>
    <p:sldId id="257" r:id="rId6"/>
    <p:sldId id="270" r:id="rId7"/>
    <p:sldId id="269" r:id="rId8"/>
    <p:sldId id="266" r:id="rId9"/>
    <p:sldId id="274" r:id="rId10"/>
    <p:sldId id="267" r:id="rId11"/>
    <p:sldId id="260" r:id="rId12"/>
    <p:sldId id="259" r:id="rId13"/>
    <p:sldId id="258" r:id="rId14"/>
    <p:sldId id="262" r:id="rId15"/>
    <p:sldId id="276" r:id="rId16"/>
    <p:sldId id="268" r:id="rId17"/>
    <p:sldId id="272" r:id="rId18"/>
    <p:sldId id="263" r:id="rId19"/>
    <p:sldId id="264" r:id="rId20"/>
    <p:sldId id="265" r:id="rId21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060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83" d="100"/>
          <a:sy n="83" d="100"/>
        </p:scale>
        <p:origin x="348" y="7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even Baginski" userId="5c4a599deb01431f" providerId="LiveId" clId="{CA1672A0-98E0-4B38-8FEE-0F054550A6C0}"/>
    <pc:docChg chg="modSld">
      <pc:chgData name="Steven Baginski" userId="5c4a599deb01431f" providerId="LiveId" clId="{CA1672A0-98E0-4B38-8FEE-0F054550A6C0}" dt="2023-07-04T14:44:57.759" v="19" actId="20577"/>
      <pc:docMkLst>
        <pc:docMk/>
      </pc:docMkLst>
      <pc:sldChg chg="modSp mod">
        <pc:chgData name="Steven Baginski" userId="5c4a599deb01431f" providerId="LiveId" clId="{CA1672A0-98E0-4B38-8FEE-0F054550A6C0}" dt="2023-07-04T14:44:57.759" v="19" actId="20577"/>
        <pc:sldMkLst>
          <pc:docMk/>
          <pc:sldMk cId="2054461792" sldId="267"/>
        </pc:sldMkLst>
        <pc:spChg chg="mod">
          <ac:chgData name="Steven Baginski" userId="5c4a599deb01431f" providerId="LiveId" clId="{CA1672A0-98E0-4B38-8FEE-0F054550A6C0}" dt="2023-07-04T14:44:57.759" v="19" actId="20577"/>
          <ac:spMkLst>
            <pc:docMk/>
            <pc:sldMk cId="2054461792" sldId="267"/>
            <ac:spMk id="2" creationId="{B842B03A-11B3-42DA-A99D-ACC4C035BB6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01AED6-EC6C-3DAD-E115-906B39F4C4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DB7166-4116-A3C8-679F-FC67D3E456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094E14-072B-B626-D978-CEE276EDF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62EF50-3E1F-78D7-978E-DAB487226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5498C7-82FE-514B-5ED3-003F7A6FE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86463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1EDD2-1BDA-48F8-1CFB-067524E52B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7D2CFA-A16A-3FF0-17B7-FD9EE9E966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DF6D2D-6E86-C065-2A93-8D9122C8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CA6249-7172-6D70-222A-C2B6B5013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580348-8616-46BB-EAE8-852E8A2DE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37264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5630E2-89E5-E13E-AE3C-DADC185123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5E39EE-061F-2FC7-6AA3-82FC2D1782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4EEEA9-CF6D-CA8D-6398-9DBB989E8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D31A2-6A6C-CD55-A1A7-445C8D6AA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8FB5B9-0AED-1D32-98B7-C7D9A21A9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4483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B3A66B-A9BE-56EE-B319-FBE7D27C8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2218E4-D8CB-CBB2-C38F-701B4D1855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3578E-3148-57CB-BCDE-E66A229D9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2B7AC8-AAB6-0230-F7CB-2AD2B517D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CC46B-5FBA-6BD0-08FE-C3FC12D56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5919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20A00-DF1A-4D11-8226-E407EE8393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AE3CDA-C249-2A35-069A-9CC03AC411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73282A-AF39-E157-50DF-31CA0CEAE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3F276B-7310-25DA-0C25-2EF229AA12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39A921-D804-F394-2795-FE5DDB296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84465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5E40DE-7FC5-3141-1619-3FBFAC4AF9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2DF705-0EE5-3688-7FBE-AE97868CCC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B2D7CA-CC9D-9F8B-DC97-4D42861877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4D9D6F-38D6-E18A-B31B-8986FF714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2581EE-5FB0-656A-8EA4-76D3047F4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C2B098-D82E-83F6-5209-1908A692E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65690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6A1B33-D59A-3359-0C63-B5B3C3AD0A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21C30E-B5CD-FF64-C895-9374E6409E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9BA957-8FD8-9910-A6A1-F1FE0F0D42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5B489C-9494-4529-5BAA-C0C44B0A9A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F674FC-3513-2CB7-4675-34253BB72D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98264F-7B92-6755-1142-3F7E9EACD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A25CD6-7DAB-DC83-A578-24E001FD2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810761-8307-EEA3-2E78-930CCE436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46145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52064-16CA-87BB-8527-90245E515C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54B580-C086-9087-8B87-8FAE23114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7B9362-D5FC-C101-C0B9-99F85F8C4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F0C4F44-6CBE-44D5-DBEC-B113FC282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44013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87DE53-29AE-C163-D6FB-67F44FCBF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5541C77-4FBD-37DB-C00E-F405B06AF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BA2592-8593-C021-D31F-429050971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4512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3F68B-B4D2-D08B-0B96-A0876DF40F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F6A33D-3D9A-EFC4-A64C-BDC27E849B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64E0EB-1AD5-EE04-C176-069302C3C3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ECE5D0-587F-F08D-BB81-356E7F9B6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05C6D2-4965-C00B-0FFE-F154F91AB3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2E8053-AB86-9959-5431-4983CC1F8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01387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D4DDC0-14C3-0EDF-1287-46B95F386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EE8286-FD1A-6DB9-21B8-910C358173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CC86C4-9029-218A-5278-07AE4966BA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345B5E-3DE0-F11D-1357-5789BB7E0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7C0482-297D-13C4-4CA8-522202D27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FE233-0804-6932-A26D-3B047861C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7667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CEEBEB8-2255-168F-B2F7-58C9C4482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BA4F9D-1E0D-2BA9-96E3-0191B77875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F3981E-3634-0EB3-9600-994EB8998A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C082D-9797-43CA-BE47-FDA228185526}" type="datetimeFigureOut">
              <a:rPr lang="sv-SE" smtClean="0"/>
              <a:t>2023-07-0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01EC2E-E29D-41FF-F077-7FDF9DF3F4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5C167D-F0B5-3604-3BB0-A99069A62A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4DD0E-3691-4B2B-B966-1904FB94077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19406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3" Type="http://schemas.openxmlformats.org/officeDocument/2006/relationships/image" Target="../media/image41.emf"/><Relationship Id="rId7" Type="http://schemas.openxmlformats.org/officeDocument/2006/relationships/image" Target="../media/image4.emf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42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8.emf"/><Relationship Id="rId5" Type="http://schemas.openxmlformats.org/officeDocument/2006/relationships/image" Target="../media/image4.emf"/><Relationship Id="rId4" Type="http://schemas.openxmlformats.org/officeDocument/2006/relationships/image" Target="../media/image47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7" Type="http://schemas.openxmlformats.org/officeDocument/2006/relationships/image" Target="../media/image53.emf"/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2.emf"/><Relationship Id="rId5" Type="http://schemas.openxmlformats.org/officeDocument/2006/relationships/image" Target="../media/image51.emf"/><Relationship Id="rId4" Type="http://schemas.openxmlformats.org/officeDocument/2006/relationships/image" Target="../media/image4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8.emf"/><Relationship Id="rId5" Type="http://schemas.openxmlformats.org/officeDocument/2006/relationships/image" Target="../media/image57.emf"/><Relationship Id="rId4" Type="http://schemas.openxmlformats.org/officeDocument/2006/relationships/image" Target="../media/image56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7" Type="http://schemas.openxmlformats.org/officeDocument/2006/relationships/image" Target="../media/image63.emf"/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2.emf"/><Relationship Id="rId5" Type="http://schemas.openxmlformats.org/officeDocument/2006/relationships/image" Target="../media/image4.emf"/><Relationship Id="rId4" Type="http://schemas.openxmlformats.org/officeDocument/2006/relationships/image" Target="../media/image61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emf"/><Relationship Id="rId2" Type="http://schemas.openxmlformats.org/officeDocument/2006/relationships/image" Target="../media/image64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8.emf"/><Relationship Id="rId5" Type="http://schemas.openxmlformats.org/officeDocument/2006/relationships/image" Target="../media/image67.emf"/><Relationship Id="rId4" Type="http://schemas.openxmlformats.org/officeDocument/2006/relationships/image" Target="../media/image66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emf"/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72.emf"/><Relationship Id="rId5" Type="http://schemas.openxmlformats.org/officeDocument/2006/relationships/image" Target="../media/image71.emf"/><Relationship Id="rId4" Type="http://schemas.openxmlformats.org/officeDocument/2006/relationships/image" Target="../media/image4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emf"/><Relationship Id="rId2" Type="http://schemas.openxmlformats.org/officeDocument/2006/relationships/image" Target="../media/image7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76.emf"/><Relationship Id="rId4" Type="http://schemas.openxmlformats.org/officeDocument/2006/relationships/image" Target="../media/image75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w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9.emf"/><Relationship Id="rId5" Type="http://schemas.openxmlformats.org/officeDocument/2006/relationships/image" Target="../media/image4.em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2.emf"/><Relationship Id="rId5" Type="http://schemas.openxmlformats.org/officeDocument/2006/relationships/image" Target="../media/image4.emf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wmf"/><Relationship Id="rId3" Type="http://schemas.openxmlformats.org/officeDocument/2006/relationships/image" Target="../media/image14.emf"/><Relationship Id="rId7" Type="http://schemas.openxmlformats.org/officeDocument/2006/relationships/oleObject" Target="../embeddings/oleObject2.bin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25.emf"/><Relationship Id="rId7" Type="http://schemas.openxmlformats.org/officeDocument/2006/relationships/image" Target="../media/image29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8.emf"/><Relationship Id="rId5" Type="http://schemas.openxmlformats.org/officeDocument/2006/relationships/image" Target="../media/image27.emf"/><Relationship Id="rId10" Type="http://schemas.openxmlformats.org/officeDocument/2006/relationships/image" Target="../media/image4.emf"/><Relationship Id="rId4" Type="http://schemas.openxmlformats.org/officeDocument/2006/relationships/image" Target="../media/image26.emf"/><Relationship Id="rId9" Type="http://schemas.openxmlformats.org/officeDocument/2006/relationships/image" Target="../media/image30.w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emf"/><Relationship Id="rId3" Type="http://schemas.openxmlformats.org/officeDocument/2006/relationships/image" Target="../media/image32.emf"/><Relationship Id="rId7" Type="http://schemas.openxmlformats.org/officeDocument/2006/relationships/image" Target="../media/image4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4.w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9.emf"/><Relationship Id="rId5" Type="http://schemas.openxmlformats.org/officeDocument/2006/relationships/image" Target="../media/image38.emf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235163-F70C-3CA7-D848-9887E0FB3C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5811838"/>
          </a:xfrm>
        </p:spPr>
        <p:txBody>
          <a:bodyPr>
            <a:normAutofit lnSpcReduction="10000"/>
          </a:bodyPr>
          <a:lstStyle/>
          <a:p>
            <a:pPr marL="0" indent="0" algn="ctr">
              <a:buNone/>
            </a:pPr>
            <a:r>
              <a:rPr lang="en-GB" b="1" dirty="0"/>
              <a:t>The Metabolic Profile of the Synthetic Cannabinoid Receptor Agonist ADB-HEXINACA using Human Hepatocytes, LC-QTOF-MS and Synthesized Reference Standards  </a:t>
            </a:r>
          </a:p>
          <a:p>
            <a:pPr marL="0" indent="0">
              <a:buNone/>
            </a:pPr>
            <a:endParaRPr lang="en-GB" sz="1400" dirty="0"/>
          </a:p>
          <a:p>
            <a:pPr marL="0" indent="0" algn="ctr">
              <a:buNone/>
            </a:pPr>
            <a:r>
              <a:rPr lang="en-GB" sz="1400" dirty="0"/>
              <a:t>Steven R. Baginski</a:t>
            </a:r>
            <a:r>
              <a:rPr lang="en-GB" sz="1400" baseline="30000" dirty="0"/>
              <a:t>1</a:t>
            </a:r>
            <a:r>
              <a:rPr lang="en-GB" sz="1400" dirty="0"/>
              <a:t>, Tobias Rautio</a:t>
            </a:r>
            <a:r>
              <a:rPr lang="en-GB" sz="1400" baseline="30000" dirty="0"/>
              <a:t>2</a:t>
            </a:r>
            <a:r>
              <a:rPr lang="en-GB" sz="1400" dirty="0"/>
              <a:t>, Lorna A. Nisbet</a:t>
            </a:r>
            <a:r>
              <a:rPr lang="en-GB" sz="1400" baseline="30000" dirty="0"/>
              <a:t>1</a:t>
            </a:r>
            <a:r>
              <a:rPr lang="en-GB" sz="1400" dirty="0"/>
              <a:t>, Karin Lindbom</a:t>
            </a:r>
            <a:r>
              <a:rPr lang="en-GB" sz="1400" baseline="30000" dirty="0"/>
              <a:t>3</a:t>
            </a:r>
            <a:r>
              <a:rPr lang="en-GB" sz="1400" dirty="0"/>
              <a:t>, </a:t>
            </a:r>
            <a:r>
              <a:rPr lang="en-GB" sz="1400" dirty="0" err="1"/>
              <a:t>Xiongyu</a:t>
            </a:r>
            <a:r>
              <a:rPr lang="en-GB" sz="1400" dirty="0"/>
              <a:t> Wu</a:t>
            </a:r>
            <a:r>
              <a:rPr lang="en-GB" sz="1400" baseline="30000" dirty="0"/>
              <a:t>2</a:t>
            </a:r>
            <a:r>
              <a:rPr lang="en-GB" sz="1400" dirty="0"/>
              <a:t>, Johan Dahlen</a:t>
            </a:r>
            <a:r>
              <a:rPr lang="en-GB" sz="1400" baseline="30000" dirty="0"/>
              <a:t>2</a:t>
            </a:r>
            <a:r>
              <a:rPr lang="en-GB" sz="1400" dirty="0"/>
              <a:t>, Craig McKenzie</a:t>
            </a:r>
            <a:r>
              <a:rPr lang="en-GB" sz="1400" baseline="30000" dirty="0"/>
              <a:t>1,4</a:t>
            </a:r>
            <a:r>
              <a:rPr lang="en-GB" sz="1400" dirty="0"/>
              <a:t>, and Henrik Gréen</a:t>
            </a:r>
            <a:r>
              <a:rPr lang="en-GB" sz="1400" baseline="30000" dirty="0"/>
              <a:t>3,5</a:t>
            </a:r>
            <a:endParaRPr lang="en-GB" sz="1400" dirty="0"/>
          </a:p>
          <a:p>
            <a:pPr marL="0" indent="0" algn="ctr">
              <a:buNone/>
            </a:pPr>
            <a:endParaRPr lang="en-GB" sz="1400" dirty="0"/>
          </a:p>
          <a:p>
            <a:pPr marL="0" indent="0">
              <a:buNone/>
            </a:pPr>
            <a:r>
              <a:rPr lang="en-GB" sz="1400" baseline="30000" dirty="0"/>
              <a:t>1</a:t>
            </a:r>
            <a:r>
              <a:rPr lang="en-GB" sz="1400" dirty="0"/>
              <a:t>Leverhulme Research Centre for Forensic Science, School of Science and Engineering, University of Dundee, Dundee, UK</a:t>
            </a:r>
          </a:p>
          <a:p>
            <a:pPr marL="0" indent="0">
              <a:buNone/>
            </a:pPr>
            <a:r>
              <a:rPr lang="en-GB" sz="1400" baseline="30000" dirty="0"/>
              <a:t>2</a:t>
            </a:r>
            <a:r>
              <a:rPr lang="en-GB" sz="1400" dirty="0"/>
              <a:t>Department of Physics, Chemistry and Biology, Linköping University, Linköping, Sweden</a:t>
            </a:r>
          </a:p>
          <a:p>
            <a:pPr marL="0" indent="0">
              <a:buNone/>
            </a:pPr>
            <a:r>
              <a:rPr lang="en-GB" sz="1400" baseline="30000" dirty="0"/>
              <a:t>3</a:t>
            </a:r>
            <a:r>
              <a:rPr lang="en-GB" sz="1400" dirty="0"/>
              <a:t>Division of Clinical Chemistry and Pharmacology, Department of Biomedical and Clinical Sciences, Faculty of Medicine and Health Sciences, Linköping University, Linköping, Sweden</a:t>
            </a:r>
          </a:p>
          <a:p>
            <a:pPr marL="0" indent="0">
              <a:buNone/>
            </a:pPr>
            <a:r>
              <a:rPr lang="en-GB" sz="1400" baseline="30000" dirty="0"/>
              <a:t>4</a:t>
            </a:r>
            <a:r>
              <a:rPr lang="en-GB" sz="1400" dirty="0"/>
              <a:t>Chiron AS, Trondheim, Norway</a:t>
            </a:r>
          </a:p>
          <a:p>
            <a:pPr marL="0" indent="0">
              <a:buNone/>
            </a:pPr>
            <a:r>
              <a:rPr lang="en-GB" sz="1400" baseline="30000" dirty="0"/>
              <a:t>5</a:t>
            </a:r>
            <a:r>
              <a:rPr lang="en-GB" sz="1400" dirty="0"/>
              <a:t>Department of Forensic Genetics and Forensic Toxicology, National Board of Forensic Medicine, Linköping, Sweden</a:t>
            </a:r>
          </a:p>
          <a:p>
            <a:pPr marL="0" indent="0">
              <a:buNone/>
            </a:pPr>
            <a:endParaRPr kumimoji="0" lang="en-GB" sz="2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  <a:p>
            <a:pPr marL="0" indent="0" algn="ctr">
              <a:buNone/>
            </a:pPr>
            <a:r>
              <a:rPr kumimoji="0" lang="en-GB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Supplementary Data S2</a:t>
            </a:r>
          </a:p>
          <a:p>
            <a:pPr marL="0" indent="0" algn="ctr">
              <a:buNone/>
            </a:pPr>
            <a:r>
              <a:rPr lang="en-GB" b="1" dirty="0">
                <a:solidFill>
                  <a:prstClr val="black"/>
                </a:solidFill>
              </a:rPr>
              <a:t>Chromatograms and Mass Spectra of Metabolites Identified</a:t>
            </a:r>
          </a:p>
          <a:p>
            <a:pPr marL="0" indent="0">
              <a:buNone/>
            </a:pPr>
            <a:endParaRPr lang="en-GB" sz="1000" dirty="0">
              <a:solidFill>
                <a:prstClr val="black"/>
              </a:solidFill>
            </a:endParaRPr>
          </a:p>
          <a:p>
            <a:pPr marL="0" indent="0">
              <a:buNone/>
            </a:pPr>
            <a:r>
              <a:rPr lang="en-GB" sz="1200" dirty="0">
                <a:solidFill>
                  <a:prstClr val="black"/>
                </a:solidFill>
              </a:rPr>
              <a:t>Note: </a:t>
            </a:r>
            <a:r>
              <a:rPr lang="en-GB" sz="1200" i="1" dirty="0">
                <a:solidFill>
                  <a:prstClr val="black"/>
                </a:solidFill>
              </a:rPr>
              <a:t>Average</a:t>
            </a:r>
            <a:r>
              <a:rPr lang="en-GB" sz="1200" dirty="0">
                <a:solidFill>
                  <a:prstClr val="black"/>
                </a:solidFill>
              </a:rPr>
              <a:t> retention time is displayed at the top of each page for all compounds; this may differ slightly from the retention time shown in each chromatogram, which corresponds to a singular sample timepoint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3494089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BA020A-F253-BA14-DC14-6ACC959F27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24869"/>
            <a:ext cx="10515600" cy="1325563"/>
          </a:xfrm>
        </p:spPr>
        <p:txBody>
          <a:bodyPr>
            <a:normAutofit/>
          </a:bodyPr>
          <a:lstStyle/>
          <a:p>
            <a:r>
              <a:rPr lang="sv-SE" sz="2800" dirty="0"/>
              <a:t>M9, Ketone formation (5-oxo-hexyl), RT 6.75 min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086FB58-8928-F72D-62BE-CF620C4C7D2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-1" y="4299827"/>
            <a:ext cx="9232075" cy="2532542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9C72173-4AE3-6FAE-4066-EE0A3B0E24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589822"/>
            <a:ext cx="9232075" cy="2634696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2B70FE75-1694-4B7B-1722-2DCA05C687E3}"/>
              </a:ext>
            </a:extLst>
          </p:cNvPr>
          <p:cNvGrpSpPr/>
          <p:nvPr/>
        </p:nvGrpSpPr>
        <p:grpSpPr>
          <a:xfrm>
            <a:off x="9232074" y="529716"/>
            <a:ext cx="2959925" cy="6293522"/>
            <a:chOff x="9232074" y="489459"/>
            <a:chExt cx="2959925" cy="6293522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1249009-B68E-4F28-8C18-84F8ADAF830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399605" y="4363387"/>
              <a:ext cx="1743075" cy="2009775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968C271-ED98-E6D6-0216-A95903AAA4CC}"/>
                </a:ext>
              </a:extLst>
            </p:cNvPr>
            <p:cNvSpPr txBox="1"/>
            <p:nvPr/>
          </p:nvSpPr>
          <p:spPr>
            <a:xfrm>
              <a:off x="9478159" y="4145982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0AB2EE7-9D85-ADCA-57AF-DBC56477EF04}"/>
                </a:ext>
              </a:extLst>
            </p:cNvPr>
            <p:cNvSpPr txBox="1"/>
            <p:nvPr/>
          </p:nvSpPr>
          <p:spPr>
            <a:xfrm>
              <a:off x="10429499" y="5549329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3.1128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927D2C1-F772-EE8A-7805-DAFC83C5CD3E}"/>
                </a:ext>
              </a:extLst>
            </p:cNvPr>
            <p:cNvSpPr txBox="1"/>
            <p:nvPr/>
          </p:nvSpPr>
          <p:spPr>
            <a:xfrm>
              <a:off x="9431648" y="6444427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99.0804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D01FC04-9B09-25DD-25D7-886E7DB56E8D}"/>
                </a:ext>
              </a:extLst>
            </p:cNvPr>
            <p:cNvSpPr txBox="1"/>
            <p:nvPr/>
          </p:nvSpPr>
          <p:spPr>
            <a:xfrm>
              <a:off x="10350285" y="1568972"/>
              <a:ext cx="184171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Confirmed with synthesized standard.</a:t>
              </a:r>
            </a:p>
          </p:txBody>
        </p:sp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21FD78C3-B2D7-5F58-DE02-90D06893DDD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5893294"/>
                </p:ext>
              </p:extLst>
            </p:nvPr>
          </p:nvGraphicFramePr>
          <p:xfrm>
            <a:off x="9261968" y="5536009"/>
            <a:ext cx="1050925" cy="931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hemSketch" r:id="rId5" imgW="1051560" imgH="931680" progId="ACD.ChemSketch.20">
                    <p:embed/>
                  </p:oleObj>
                </mc:Choice>
                <mc:Fallback>
                  <p:oleObj name="ChemSketch" r:id="rId5" imgW="1051560" imgH="931680" progId="ACD.ChemSketch.20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21FD78C3-B2D7-5F58-DE02-90D06893DDD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9261968" y="5536009"/>
                          <a:ext cx="1050925" cy="931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92039765-6346-46DE-B6EF-5DE13188D3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42984" b="47596"/>
            <a:stretch/>
          </p:blipFill>
          <p:spPr>
            <a:xfrm>
              <a:off x="9524671" y="3063951"/>
              <a:ext cx="1102458" cy="118297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A92B015-98EE-4D59-99F3-55EED42D7C2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232074" y="489459"/>
              <a:ext cx="1771650" cy="2428875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44D1027-A7E2-475E-BDA3-9A8A60F0D91D}"/>
                </a:ext>
              </a:extLst>
            </p:cNvPr>
            <p:cNvSpPr txBox="1"/>
            <p:nvPr/>
          </p:nvSpPr>
          <p:spPr>
            <a:xfrm>
              <a:off x="10996518" y="643883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3.223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358351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E3A63-AE8A-02C2-32C3-F53353BB0B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sv-SE" sz="2800" dirty="0"/>
              <a:t>M10, Mono-hydroxylation (hexyl tail), RT 7.07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A6D216A6-E14C-4C80-A1DB-0F3E8E3FAB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99" y="1690688"/>
            <a:ext cx="8810367" cy="250061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539B274-3120-45EC-83AA-33FFAAC484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0860" y="4418995"/>
            <a:ext cx="8945284" cy="234187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C6655390-B5CE-C228-608B-49AF56B05B29}"/>
              </a:ext>
            </a:extLst>
          </p:cNvPr>
          <p:cNvGrpSpPr/>
          <p:nvPr/>
        </p:nvGrpSpPr>
        <p:grpSpPr>
          <a:xfrm>
            <a:off x="8944999" y="191746"/>
            <a:ext cx="3118371" cy="6322961"/>
            <a:chOff x="8944999" y="232002"/>
            <a:chExt cx="3118371" cy="6322961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93AABE5D-D220-5195-B798-55FC5B3062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45435" b="48332"/>
            <a:stretch/>
          </p:blipFill>
          <p:spPr>
            <a:xfrm>
              <a:off x="8944999" y="2531949"/>
              <a:ext cx="1897026" cy="1865203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833C9AE-CEDD-472E-9EF0-567AA9DF7B55}"/>
                </a:ext>
              </a:extLst>
            </p:cNvPr>
            <p:cNvSpPr txBox="1"/>
            <p:nvPr/>
          </p:nvSpPr>
          <p:spPr>
            <a:xfrm>
              <a:off x="10428641" y="4450972"/>
              <a:ext cx="676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/>
                <a:t>− H</a:t>
              </a:r>
              <a:r>
                <a:rPr lang="sv-SE" sz="1200" baseline="-25000" dirty="0"/>
                <a:t>2</a:t>
              </a:r>
              <a:r>
                <a:rPr lang="sv-SE" sz="1200" dirty="0"/>
                <a:t>O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DBFFFC6-9300-4F1F-8FF8-D9B654FCD748}"/>
                </a:ext>
              </a:extLst>
            </p:cNvPr>
            <p:cNvSpPr txBox="1"/>
            <p:nvPr/>
          </p:nvSpPr>
          <p:spPr>
            <a:xfrm>
              <a:off x="9447078" y="4230426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5.128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08F5082-D1DE-4994-91EF-789206FEA70B}"/>
                </a:ext>
              </a:extLst>
            </p:cNvPr>
            <p:cNvSpPr txBox="1"/>
            <p:nvPr/>
          </p:nvSpPr>
          <p:spPr>
            <a:xfrm>
              <a:off x="10867889" y="4230426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27.1179</a:t>
              </a: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F5323851-A448-42FD-BCD5-EF6B6A298E28}"/>
                </a:ext>
              </a:extLst>
            </p:cNvPr>
            <p:cNvCxnSpPr>
              <a:cxnSpLocks/>
            </p:cNvCxnSpPr>
            <p:nvPr/>
          </p:nvCxnSpPr>
          <p:spPr>
            <a:xfrm>
              <a:off x="10593145" y="4416367"/>
              <a:ext cx="173602" cy="1538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D84C59C-ED98-4545-86F0-5C3AF0AD13B4}"/>
                </a:ext>
              </a:extLst>
            </p:cNvPr>
            <p:cNvSpPr txBox="1"/>
            <p:nvPr/>
          </p:nvSpPr>
          <p:spPr>
            <a:xfrm>
              <a:off x="10116270" y="6216409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8FA098D7-0DEB-4017-94EA-19F93F381C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2984" b="47596"/>
            <a:stretch/>
          </p:blipFill>
          <p:spPr>
            <a:xfrm>
              <a:off x="10178131" y="5162762"/>
              <a:ext cx="1102458" cy="1182971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BAAF3E5-F482-4A2A-A769-8217A59D2908}"/>
                </a:ext>
              </a:extLst>
            </p:cNvPr>
            <p:cNvSpPr txBox="1"/>
            <p:nvPr/>
          </p:nvSpPr>
          <p:spPr>
            <a:xfrm>
              <a:off x="10667499" y="1175272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5.2391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B0D6C33-7D6D-0FCB-F92D-38AA76F1EC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48047" b="46800"/>
            <a:stretch/>
          </p:blipFill>
          <p:spPr>
            <a:xfrm>
              <a:off x="9268954" y="232002"/>
              <a:ext cx="1835899" cy="236642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571944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02BE74-7EEC-498B-8AF8-61FF06D8E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11, Ketone formation (4-oxo-hexyl), RT 7.2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4109E32-01D8-40A1-89D9-107CDAFEC4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269" y="1444198"/>
            <a:ext cx="9031394" cy="244399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26AC1BA-8891-42CE-92EC-2E12913F3E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269" y="4048886"/>
            <a:ext cx="9159194" cy="2443989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027C82AC-087B-DD64-AA6F-91A349896371}"/>
              </a:ext>
            </a:extLst>
          </p:cNvPr>
          <p:cNvGrpSpPr/>
          <p:nvPr/>
        </p:nvGrpSpPr>
        <p:grpSpPr>
          <a:xfrm>
            <a:off x="9239654" y="292616"/>
            <a:ext cx="2978494" cy="6439979"/>
            <a:chOff x="9239654" y="292616"/>
            <a:chExt cx="2978494" cy="6439979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1817739-8497-4DBD-B890-C066810EE7B2}"/>
                </a:ext>
              </a:extLst>
            </p:cNvPr>
            <p:cNvSpPr txBox="1"/>
            <p:nvPr/>
          </p:nvSpPr>
          <p:spPr>
            <a:xfrm>
              <a:off x="9567862" y="4409964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3.1128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1423EE1-5AB2-4230-9EFF-BC654C8A9F48}"/>
                </a:ext>
              </a:extLst>
            </p:cNvPr>
            <p:cNvSpPr txBox="1"/>
            <p:nvPr/>
          </p:nvSpPr>
          <p:spPr>
            <a:xfrm>
              <a:off x="9444855" y="6394041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0303DC6-DDA6-4745-A53C-E3B68FF09350}"/>
                </a:ext>
              </a:extLst>
            </p:cNvPr>
            <p:cNvSpPr txBox="1"/>
            <p:nvPr/>
          </p:nvSpPr>
          <p:spPr>
            <a:xfrm>
              <a:off x="10928032" y="6148872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99.080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7CCF7F8-76E2-4C0E-80AF-0EF95C4D2C5B}"/>
                </a:ext>
              </a:extLst>
            </p:cNvPr>
            <p:cNvSpPr txBox="1"/>
            <p:nvPr/>
          </p:nvSpPr>
          <p:spPr>
            <a:xfrm>
              <a:off x="10996519" y="362144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3.2234</a:t>
              </a: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09D7ABD1-1682-4241-9A09-F882A62580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42984" b="47596"/>
            <a:stretch/>
          </p:blipFill>
          <p:spPr>
            <a:xfrm>
              <a:off x="9444855" y="5271234"/>
              <a:ext cx="1102458" cy="118297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F39A5C4-E4A1-138A-27DC-FCEFCA7D3D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7409" b="49999"/>
            <a:stretch/>
          </p:blipFill>
          <p:spPr>
            <a:xfrm>
              <a:off x="10713705" y="5392736"/>
              <a:ext cx="1167172" cy="795338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471F4C2-27FF-ED50-DC87-12621315BC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48210" b="48222"/>
            <a:stretch/>
          </p:blipFill>
          <p:spPr>
            <a:xfrm>
              <a:off x="9239654" y="292616"/>
              <a:ext cx="1830148" cy="2303163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049C8F8-E854-B927-99A2-75AA8EB8CC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47849" b="47650"/>
            <a:stretch/>
          </p:blipFill>
          <p:spPr>
            <a:xfrm>
              <a:off x="9444855" y="2936083"/>
              <a:ext cx="1813075" cy="1889814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A0F7A4F-DA71-C588-E631-1726DD4CF06D}"/>
                </a:ext>
              </a:extLst>
            </p:cNvPr>
            <p:cNvSpPr txBox="1"/>
            <p:nvPr/>
          </p:nvSpPr>
          <p:spPr>
            <a:xfrm>
              <a:off x="10376434" y="1089765"/>
              <a:ext cx="184171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Confirmed with synthesized standard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581637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9E535-0FA2-4BB9-BC57-9443917CDE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12, Ketone formation (hexyl tail), RT 7.61 min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C8A941F-B187-40AF-B2B8-313D57C42B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38" y="4269075"/>
            <a:ext cx="9303391" cy="248246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BA81AE1-4E3E-40AE-AA93-F975E0CA3B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4996" y="1690688"/>
            <a:ext cx="9445658" cy="255609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84214149-175D-890D-5527-D6D25AEA71BE}"/>
              </a:ext>
            </a:extLst>
          </p:cNvPr>
          <p:cNvGrpSpPr/>
          <p:nvPr/>
        </p:nvGrpSpPr>
        <p:grpSpPr>
          <a:xfrm>
            <a:off x="9659828" y="284613"/>
            <a:ext cx="2259201" cy="6305356"/>
            <a:chOff x="9659828" y="324869"/>
            <a:chExt cx="2259201" cy="6305356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6ED95F9-0E1D-4A99-B6DE-A64006F9F3FA}"/>
                </a:ext>
              </a:extLst>
            </p:cNvPr>
            <p:cNvSpPr txBox="1"/>
            <p:nvPr/>
          </p:nvSpPr>
          <p:spPr>
            <a:xfrm>
              <a:off x="10125807" y="4481921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3.112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CDF24C8-76C0-4D3B-9F24-F9222A865EC5}"/>
                </a:ext>
              </a:extLst>
            </p:cNvPr>
            <p:cNvSpPr txBox="1"/>
            <p:nvPr/>
          </p:nvSpPr>
          <p:spPr>
            <a:xfrm>
              <a:off x="10369639" y="6291671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99.0804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A851E6A-BC0C-4855-8963-058A69909034}"/>
                </a:ext>
              </a:extLst>
            </p:cNvPr>
            <p:cNvSpPr txBox="1"/>
            <p:nvPr/>
          </p:nvSpPr>
          <p:spPr>
            <a:xfrm>
              <a:off x="10723548" y="1198981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3.2234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ABBDBCB-D649-39AB-61EC-726D507AE7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48210" b="48093"/>
            <a:stretch/>
          </p:blipFill>
          <p:spPr>
            <a:xfrm>
              <a:off x="9659828" y="324869"/>
              <a:ext cx="1830148" cy="230891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17DB9AA-4198-D3B0-487C-29D4B6EFD9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7358" b="46854"/>
            <a:stretch/>
          </p:blipFill>
          <p:spPr>
            <a:xfrm>
              <a:off x="9659828" y="2809759"/>
              <a:ext cx="1830149" cy="1918569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7AB863E-C832-408A-10CB-27F24A396F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" r="46769" b="43944"/>
            <a:stretch/>
          </p:blipFill>
          <p:spPr>
            <a:xfrm>
              <a:off x="10257927" y="5584671"/>
              <a:ext cx="1232049" cy="89166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1921237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3683A6-2DC0-4A2F-ADAD-C1DC49949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13, Terminal amide hydrolysis + ketone formation </a:t>
            </a:r>
            <a:br>
              <a:rPr lang="en-GB" sz="2800" dirty="0"/>
            </a:br>
            <a:r>
              <a:rPr lang="en-GB" sz="2800" dirty="0"/>
              <a:t>(5-oxo-hexyl), RT 7.67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F933C2F-0B37-40F6-AE33-2E97B217EC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24568"/>
            <a:ext cx="9568546" cy="258934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FC3FB66-E0FF-4085-BC57-53AA6516C9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10525" y="4213916"/>
            <a:ext cx="9703949" cy="2589348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8F55ED5C-064E-B951-9837-E7858587B053}"/>
              </a:ext>
            </a:extLst>
          </p:cNvPr>
          <p:cNvGrpSpPr/>
          <p:nvPr/>
        </p:nvGrpSpPr>
        <p:grpSpPr>
          <a:xfrm>
            <a:off x="9578348" y="271299"/>
            <a:ext cx="2712498" cy="6517378"/>
            <a:chOff x="9578348" y="271299"/>
            <a:chExt cx="2712498" cy="6517378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72E02E7E-32F9-4CF0-8714-C237D64CCD7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29979" y="2935745"/>
              <a:ext cx="1743075" cy="200977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4643029-2C12-4712-B2C0-9D92C65F97B6}"/>
                </a:ext>
              </a:extLst>
            </p:cNvPr>
            <p:cNvSpPr txBox="1"/>
            <p:nvPr/>
          </p:nvSpPr>
          <p:spPr>
            <a:xfrm>
              <a:off x="9829978" y="4243840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3.1128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AE3C586-E817-45E4-85AD-1B086A483545}"/>
                </a:ext>
              </a:extLst>
            </p:cNvPr>
            <p:cNvSpPr txBox="1"/>
            <p:nvPr/>
          </p:nvSpPr>
          <p:spPr>
            <a:xfrm>
              <a:off x="9829979" y="6450123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99.080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0490F27-C1AD-46C1-80DA-58D30781E878}"/>
                </a:ext>
              </a:extLst>
            </p:cNvPr>
            <p:cNvSpPr txBox="1"/>
            <p:nvPr/>
          </p:nvSpPr>
          <p:spPr>
            <a:xfrm>
              <a:off x="11025460" y="6308209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F0487A1-0C69-16D0-6506-9CE114670A9B}"/>
                </a:ext>
              </a:extLst>
            </p:cNvPr>
            <p:cNvSpPr txBox="1"/>
            <p:nvPr/>
          </p:nvSpPr>
          <p:spPr>
            <a:xfrm>
              <a:off x="10449132" y="1027906"/>
              <a:ext cx="184171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Confirmed with synthesized standard.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EADB177-0E86-4225-8029-24805E9CC9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2984" b="47596"/>
            <a:stretch/>
          </p:blipFill>
          <p:spPr>
            <a:xfrm>
              <a:off x="11025460" y="5246168"/>
              <a:ext cx="1102458" cy="1182971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32A0481-B060-4143-AAFE-D66FB2E187B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723638" y="5502275"/>
              <a:ext cx="1114425" cy="9906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ED3BF851-8A51-4EF4-8D06-C5181605D1B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578348" y="271299"/>
              <a:ext cx="1743075" cy="2428875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045825E-90BE-47B5-8502-3A0FE7E4E068}"/>
                </a:ext>
              </a:extLst>
            </p:cNvPr>
            <p:cNvSpPr txBox="1"/>
            <p:nvPr/>
          </p:nvSpPr>
          <p:spPr>
            <a:xfrm>
              <a:off x="9591623" y="1893968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4.207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995028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E3A63-AE8A-02C2-32C3-F53353BB0B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sv-SE" sz="2800" dirty="0"/>
              <a:t>M14, Mono-hydroxylation (indazole ring), RT 8.2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0070D7C-E56D-4E62-9177-3354E573B3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14687"/>
            <a:ext cx="9146192" cy="252110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8B4E413-E99A-4EF7-8135-9738B75B2A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315053"/>
            <a:ext cx="9146192" cy="2394472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382977AB-C970-FCB6-5991-7452B0CC8F8D}"/>
              </a:ext>
            </a:extLst>
          </p:cNvPr>
          <p:cNvGrpSpPr/>
          <p:nvPr/>
        </p:nvGrpSpPr>
        <p:grpSpPr>
          <a:xfrm>
            <a:off x="9382125" y="180876"/>
            <a:ext cx="3147907" cy="6301104"/>
            <a:chOff x="9382125" y="180876"/>
            <a:chExt cx="3147907" cy="6301104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E0E8EF4-43C5-4F03-83D8-60E61C85D482}"/>
                </a:ext>
              </a:extLst>
            </p:cNvPr>
            <p:cNvSpPr txBox="1"/>
            <p:nvPr/>
          </p:nvSpPr>
          <p:spPr>
            <a:xfrm>
              <a:off x="10177568" y="6143426"/>
              <a:ext cx="23524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/>
                <a:t>161.0346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F175847-FB32-B36F-9767-DE611BB3B641}"/>
                </a:ext>
              </a:extLst>
            </p:cNvPr>
            <p:cNvGrpSpPr/>
            <p:nvPr/>
          </p:nvGrpSpPr>
          <p:grpSpPr>
            <a:xfrm>
              <a:off x="9382125" y="180876"/>
              <a:ext cx="2515810" cy="5986689"/>
              <a:chOff x="9382125" y="221133"/>
              <a:chExt cx="2515810" cy="5986689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5E0BC24-3F33-29A9-E4D8-722E3B6FD93D}"/>
                  </a:ext>
                </a:extLst>
              </p:cNvPr>
              <p:cNvSpPr txBox="1"/>
              <p:nvPr/>
            </p:nvSpPr>
            <p:spPr>
              <a:xfrm>
                <a:off x="9892736" y="4158077"/>
                <a:ext cx="119548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600" dirty="0"/>
                  <a:t>245.1285</a:t>
                </a:r>
              </a:p>
            </p:txBody>
          </p:sp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FB2E5DF6-9F68-4734-AAE6-38BEE4B6E0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382125" y="221133"/>
                <a:ext cx="1971675" cy="2228850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736357E0-B4A0-4F93-85B9-FE7AAD3CF7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726142" y="2970799"/>
                <a:ext cx="1952625" cy="1809750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1582DF1D-6A72-4F7A-8572-9D7D6F9191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0111905" y="5074347"/>
                <a:ext cx="1181100" cy="1133475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714DAB3-90DE-422C-8235-1A19C9F092E8}"/>
                  </a:ext>
                </a:extLst>
              </p:cNvPr>
              <p:cNvSpPr txBox="1"/>
              <p:nvPr/>
            </p:nvSpPr>
            <p:spPr>
              <a:xfrm>
                <a:off x="10702454" y="1191256"/>
                <a:ext cx="1195481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600" dirty="0"/>
                  <a:t>[M+H]</a:t>
                </a:r>
                <a:r>
                  <a:rPr lang="sv-SE" sz="1600" baseline="30000" dirty="0"/>
                  <a:t>+</a:t>
                </a:r>
              </a:p>
              <a:p>
                <a:pPr algn="ctr"/>
                <a:r>
                  <a:rPr lang="sv-SE" sz="1600" dirty="0"/>
                  <a:t>375.2391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5971539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E3A63-AE8A-02C2-32C3-F53353BB0B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24869"/>
            <a:ext cx="10515600" cy="1325563"/>
          </a:xfrm>
        </p:spPr>
        <p:txBody>
          <a:bodyPr>
            <a:normAutofit/>
          </a:bodyPr>
          <a:lstStyle/>
          <a:p>
            <a:r>
              <a:rPr lang="sv-SE" sz="2800" dirty="0"/>
              <a:t>M15, Mono-hydroxylation (</a:t>
            </a:r>
            <a:r>
              <a:rPr lang="sv-SE" sz="2800" i="1" dirty="0"/>
              <a:t>tert</a:t>
            </a:r>
            <a:r>
              <a:rPr lang="sv-SE" sz="2800" dirty="0"/>
              <a:t>-butyl), RT 8.61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CE79907-6BE5-4637-9F83-70A788C27C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25852"/>
            <a:ext cx="9394603" cy="258957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191B21F-34BA-4F49-BE45-F7324371E0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89333" y="4186493"/>
            <a:ext cx="9516084" cy="2491310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8F6EF985-4528-10B9-7C81-9D20F5731105}"/>
              </a:ext>
            </a:extLst>
          </p:cNvPr>
          <p:cNvGrpSpPr/>
          <p:nvPr/>
        </p:nvGrpSpPr>
        <p:grpSpPr>
          <a:xfrm>
            <a:off x="9516767" y="106477"/>
            <a:ext cx="2355103" cy="6459773"/>
            <a:chOff x="9516767" y="186990"/>
            <a:chExt cx="2355103" cy="6459773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74B04FC-6684-47A7-89EE-2BA9B9323664}"/>
                </a:ext>
              </a:extLst>
            </p:cNvPr>
            <p:cNvSpPr txBox="1"/>
            <p:nvPr/>
          </p:nvSpPr>
          <p:spPr>
            <a:xfrm>
              <a:off x="9804852" y="4449838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29.1335</a:t>
              </a:r>
            </a:p>
            <a:p>
              <a:endParaRPr lang="sv-SE" sz="16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2D4B663-92DB-41B7-A213-A8E7FD9E4200}"/>
                </a:ext>
              </a:extLst>
            </p:cNvPr>
            <p:cNvSpPr txBox="1"/>
            <p:nvPr/>
          </p:nvSpPr>
          <p:spPr>
            <a:xfrm>
              <a:off x="10234704" y="6308209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20B2748D-0F09-44D7-B023-7EB3C92D30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42984" b="47596"/>
            <a:stretch/>
          </p:blipFill>
          <p:spPr>
            <a:xfrm>
              <a:off x="10327727" y="5223716"/>
              <a:ext cx="1102458" cy="118297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B2B5D51-C260-4474-B9D5-3C3A26763BD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804852" y="3281618"/>
              <a:ext cx="1743075" cy="180975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AFA01B9-03C8-485A-9F6C-CA2A8588EDC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516767" y="186990"/>
              <a:ext cx="1771650" cy="253365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3963E6E-D118-4932-82D0-5D61E3F7827A}"/>
                </a:ext>
              </a:extLst>
            </p:cNvPr>
            <p:cNvSpPr txBox="1"/>
            <p:nvPr/>
          </p:nvSpPr>
          <p:spPr>
            <a:xfrm>
              <a:off x="10676389" y="1367522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5.239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8962903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E2B74-EC3A-4D24-9F4F-DBB752199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16, Terminal amide hydrolysis, RT 11.12 mi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FF1B6CC-EE88-4E0A-8F80-38FA6B3F52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003" y="1841118"/>
            <a:ext cx="8976220" cy="25476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451413E-E1D9-4486-9460-861E288076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501" y="4470171"/>
            <a:ext cx="9127223" cy="231483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39AF0955-946D-C9C4-F4FD-3B419BA26BAA}"/>
              </a:ext>
            </a:extLst>
          </p:cNvPr>
          <p:cNvGrpSpPr/>
          <p:nvPr/>
        </p:nvGrpSpPr>
        <p:grpSpPr>
          <a:xfrm>
            <a:off x="9325000" y="428129"/>
            <a:ext cx="2910484" cy="5321669"/>
            <a:chOff x="9325000" y="468386"/>
            <a:chExt cx="2910484" cy="532166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AD67253-7A9A-4AD2-B289-1FB2578F1B74}"/>
                </a:ext>
              </a:extLst>
            </p:cNvPr>
            <p:cNvSpPr txBox="1"/>
            <p:nvPr/>
          </p:nvSpPr>
          <p:spPr>
            <a:xfrm>
              <a:off x="11040003" y="4470171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1C80E64E-9A9F-491B-822F-92467F3EE47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477464" y="3934628"/>
              <a:ext cx="1743075" cy="180975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94E7B3F-4994-4C3D-98EF-D89786DE90A7}"/>
                </a:ext>
              </a:extLst>
            </p:cNvPr>
            <p:cNvSpPr txBox="1"/>
            <p:nvPr/>
          </p:nvSpPr>
          <p:spPr>
            <a:xfrm>
              <a:off x="9477464" y="5205280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29.1335</a:t>
              </a:r>
            </a:p>
            <a:p>
              <a:endParaRPr lang="sv-SE" sz="16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12AACD7-B187-5208-96E0-CBF9E8B29EC6}"/>
                </a:ext>
              </a:extLst>
            </p:cNvPr>
            <p:cNvSpPr txBox="1"/>
            <p:nvPr/>
          </p:nvSpPr>
          <p:spPr>
            <a:xfrm>
              <a:off x="10306515" y="1339451"/>
              <a:ext cx="184171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Confirmed with synthesized standard.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E018869-48AA-4AB6-B640-FC2AAC7BF40E}"/>
                </a:ext>
              </a:extLst>
            </p:cNvPr>
            <p:cNvSpPr txBox="1"/>
            <p:nvPr/>
          </p:nvSpPr>
          <p:spPr>
            <a:xfrm>
              <a:off x="9325000" y="2154166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60.2282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E53B782-16B5-4A7C-B311-9BB31A74041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357868" y="468386"/>
              <a:ext cx="1743075" cy="222885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262ED82A-C31A-4F9E-AFE5-C7161497AE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42984" b="47596"/>
            <a:stretch/>
          </p:blipFill>
          <p:spPr>
            <a:xfrm>
              <a:off x="10963797" y="3343142"/>
              <a:ext cx="1102458" cy="118297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709428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0C9E8-EC96-EC1B-73BC-623AE62BDF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24869"/>
            <a:ext cx="10515600" cy="1325563"/>
          </a:xfrm>
        </p:spPr>
        <p:txBody>
          <a:bodyPr>
            <a:normAutofit/>
          </a:bodyPr>
          <a:lstStyle/>
          <a:p>
            <a:r>
              <a:rPr lang="sv-SE" sz="2800" dirty="0"/>
              <a:t>ADB-HEXINACA, RT 10.30 mi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9BB1906-4E9E-839F-B6E8-D7963D2FB4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236" y="4203734"/>
            <a:ext cx="9059204" cy="248512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08D630F-B7E2-6500-4469-7376385C93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43" y="1449920"/>
            <a:ext cx="9204890" cy="262693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15F7C6F3-2AFF-5BC1-A36E-FFBF0EDD0442}"/>
              </a:ext>
            </a:extLst>
          </p:cNvPr>
          <p:cNvSpPr txBox="1"/>
          <p:nvPr/>
        </p:nvSpPr>
        <p:spPr>
          <a:xfrm>
            <a:off x="9493381" y="4650179"/>
            <a:ext cx="11954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/>
              <a:t>229.1335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0276514-04AD-723E-6761-781FA448C1BF}"/>
              </a:ext>
            </a:extLst>
          </p:cNvPr>
          <p:cNvGrpSpPr/>
          <p:nvPr/>
        </p:nvGrpSpPr>
        <p:grpSpPr>
          <a:xfrm>
            <a:off x="9420312" y="271706"/>
            <a:ext cx="2656126" cy="6350855"/>
            <a:chOff x="9420312" y="271706"/>
            <a:chExt cx="2656126" cy="6350855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6288F0B-8424-5598-256F-A5EFAEF1C565}"/>
                </a:ext>
              </a:extLst>
            </p:cNvPr>
            <p:cNvGrpSpPr/>
            <p:nvPr/>
          </p:nvGrpSpPr>
          <p:grpSpPr>
            <a:xfrm>
              <a:off x="9822491" y="271706"/>
              <a:ext cx="1898369" cy="2281210"/>
              <a:chOff x="9822491" y="271706"/>
              <a:chExt cx="1898369" cy="2281210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6218FDE-B623-902A-E478-E0AB718339DA}"/>
                  </a:ext>
                </a:extLst>
              </p:cNvPr>
              <p:cNvSpPr txBox="1"/>
              <p:nvPr/>
            </p:nvSpPr>
            <p:spPr>
              <a:xfrm>
                <a:off x="9822491" y="1968141"/>
                <a:ext cx="1195481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600" dirty="0"/>
                  <a:t>[M+H]</a:t>
                </a:r>
                <a:r>
                  <a:rPr lang="sv-SE" sz="1600" baseline="30000" dirty="0"/>
                  <a:t>+</a:t>
                </a:r>
              </a:p>
              <a:p>
                <a:pPr algn="ctr"/>
                <a:r>
                  <a:rPr lang="sv-SE" sz="1600" dirty="0"/>
                  <a:t>359.2441</a:t>
                </a:r>
              </a:p>
            </p:txBody>
          </p:sp>
          <p:graphicFrame>
            <p:nvGraphicFramePr>
              <p:cNvPr id="3" name="Object 2">
                <a:extLst>
                  <a:ext uri="{FF2B5EF4-FFF2-40B4-BE49-F238E27FC236}">
                    <a16:creationId xmlns:a16="http://schemas.microsoft.com/office/drawing/2014/main" id="{AE6278B7-F0F8-96F0-C389-1D0C9DDD301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34367871"/>
                  </p:ext>
                </p:extLst>
              </p:nvPr>
            </p:nvGraphicFramePr>
            <p:xfrm>
              <a:off x="9944335" y="271706"/>
              <a:ext cx="1776525" cy="223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hemSketch" r:id="rId4" imgW="1677240" imgH="2107800" progId="ACD.ChemSketch.20">
                      <p:embed/>
                    </p:oleObj>
                  </mc:Choice>
                  <mc:Fallback>
                    <p:oleObj name="ChemSketch" r:id="rId4" imgW="1677240" imgH="2107800" progId="ACD.ChemSketch.20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AE6278B7-F0F8-96F0-C389-1D0C9DDD301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9944335" y="271706"/>
                            <a:ext cx="1776525" cy="2232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DAF31AC-D797-07B7-CC2B-8593F88F1219}"/>
                </a:ext>
              </a:extLst>
            </p:cNvPr>
            <p:cNvGrpSpPr/>
            <p:nvPr/>
          </p:nvGrpSpPr>
          <p:grpSpPr>
            <a:xfrm>
              <a:off x="10880957" y="5241043"/>
              <a:ext cx="1195481" cy="1381518"/>
              <a:chOff x="10880957" y="5241043"/>
              <a:chExt cx="1195481" cy="1381518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3332E64-5395-6820-3C58-C009FB7947A4}"/>
                  </a:ext>
                </a:extLst>
              </p:cNvPr>
              <p:cNvSpPr txBox="1"/>
              <p:nvPr/>
            </p:nvSpPr>
            <p:spPr>
              <a:xfrm>
                <a:off x="10880957" y="6284007"/>
                <a:ext cx="119548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600" dirty="0"/>
                  <a:t>145.0396</a:t>
                </a:r>
              </a:p>
            </p:txBody>
          </p:sp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000E5321-4EF9-22F3-9AAC-E7023B846D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r="42984" b="47596"/>
              <a:stretch/>
            </p:blipFill>
            <p:spPr>
              <a:xfrm>
                <a:off x="10927468" y="5241043"/>
                <a:ext cx="1102458" cy="1182971"/>
              </a:xfrm>
              <a:prstGeom prst="rect">
                <a:avLst/>
              </a:prstGeom>
            </p:spPr>
          </p:pic>
        </p:grp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64F4D5D7-72EC-DA19-3E14-B5F49E9E81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47023" b="46695"/>
            <a:stretch/>
          </p:blipFill>
          <p:spPr>
            <a:xfrm>
              <a:off x="9420312" y="3356980"/>
              <a:ext cx="1841830" cy="192432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94541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D6D33-214C-4D9F-A782-62AAC9FD94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1, Di-hydroxylation (hexyl tail + </a:t>
            </a:r>
            <a:r>
              <a:rPr lang="en-GB" sz="2800" i="1" dirty="0"/>
              <a:t>tert</a:t>
            </a:r>
            <a:r>
              <a:rPr lang="en-GB" sz="2800" dirty="0"/>
              <a:t>-butyl), RT 5.21 mi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30D1382-98E2-4858-9D1A-67910E5761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44432"/>
            <a:ext cx="9502219" cy="269697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9C95721-D384-4390-99F3-0B85E64580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350793"/>
            <a:ext cx="9671902" cy="245297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4BFB8376-B724-573B-FA05-2345DFE229E0}"/>
              </a:ext>
            </a:extLst>
          </p:cNvPr>
          <p:cNvGrpSpPr/>
          <p:nvPr/>
        </p:nvGrpSpPr>
        <p:grpSpPr>
          <a:xfrm>
            <a:off x="9477061" y="115820"/>
            <a:ext cx="2921839" cy="6529134"/>
            <a:chOff x="9477061" y="190583"/>
            <a:chExt cx="2921839" cy="6529134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6499709-E43B-929E-491E-117444A5DDAF}"/>
                </a:ext>
              </a:extLst>
            </p:cNvPr>
            <p:cNvSpPr txBox="1"/>
            <p:nvPr/>
          </p:nvSpPr>
          <p:spPr>
            <a:xfrm>
              <a:off x="10397798" y="6381163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672A3B4-93CB-EC72-18B9-22D0E951FD7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477061" y="2627669"/>
              <a:ext cx="1800225" cy="18669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A1CB353-4F51-608D-47E2-CDE67FE0FA0A}"/>
                </a:ext>
              </a:extLst>
            </p:cNvPr>
            <p:cNvSpPr txBox="1"/>
            <p:nvPr/>
          </p:nvSpPr>
          <p:spPr>
            <a:xfrm>
              <a:off x="9780272" y="4402236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5.128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8901446-F362-E255-3929-5CC5273172EA}"/>
                </a:ext>
              </a:extLst>
            </p:cNvPr>
            <p:cNvSpPr txBox="1"/>
            <p:nvPr/>
          </p:nvSpPr>
          <p:spPr>
            <a:xfrm>
              <a:off x="11203419" y="4402236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27.1179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3442626-1775-2653-4437-B8EA87EA6783}"/>
                </a:ext>
              </a:extLst>
            </p:cNvPr>
            <p:cNvSpPr txBox="1"/>
            <p:nvPr/>
          </p:nvSpPr>
          <p:spPr>
            <a:xfrm>
              <a:off x="10761434" y="4595519"/>
              <a:ext cx="676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/>
                <a:t>−H</a:t>
              </a:r>
              <a:r>
                <a:rPr lang="sv-SE" sz="1200" baseline="-25000" dirty="0"/>
                <a:t>2</a:t>
              </a:r>
              <a:r>
                <a:rPr lang="sv-SE" sz="1200" dirty="0"/>
                <a:t>O</a:t>
              </a: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A8CC4431-C334-3DAF-5374-0215229FF12F}"/>
                </a:ext>
              </a:extLst>
            </p:cNvPr>
            <p:cNvCxnSpPr/>
            <p:nvPr/>
          </p:nvCxnSpPr>
          <p:spPr>
            <a:xfrm>
              <a:off x="10906030" y="4567251"/>
              <a:ext cx="17360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23317E7-D95B-67D9-137E-B49D91B26A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2984" b="47596"/>
            <a:stretch/>
          </p:blipFill>
          <p:spPr>
            <a:xfrm>
              <a:off x="10377174" y="5309904"/>
              <a:ext cx="1102458" cy="1182971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F6E92B7-E228-F480-8C24-371D139F97D2}"/>
                </a:ext>
              </a:extLst>
            </p:cNvPr>
            <p:cNvSpPr txBox="1"/>
            <p:nvPr/>
          </p:nvSpPr>
          <p:spPr>
            <a:xfrm>
              <a:off x="10807415" y="1356901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91.2340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FFCA803-B2D2-42D1-B46B-D598BA37346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780272" y="190583"/>
              <a:ext cx="1800225" cy="25527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541893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A2346-E436-4C31-B6FB-EF7B437B9E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2, Mono-hydroxylation + glucuronidation (hexyl tail), </a:t>
            </a:r>
            <a:br>
              <a:rPr lang="en-GB" sz="2800" dirty="0"/>
            </a:br>
            <a:r>
              <a:rPr lang="en-GB" sz="2800" dirty="0"/>
              <a:t>RT 5.21 mi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1252BA2-B795-4098-918A-F4426DCFA8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548" y="1446685"/>
            <a:ext cx="9030878" cy="256320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ED0230D-26EB-434B-90D9-EDA2B5123C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0702" y="4301945"/>
            <a:ext cx="9417377" cy="2388422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416B7C0B-C635-B787-1743-DC352FD9D7C0}"/>
              </a:ext>
            </a:extLst>
          </p:cNvPr>
          <p:cNvGrpSpPr/>
          <p:nvPr/>
        </p:nvGrpSpPr>
        <p:grpSpPr>
          <a:xfrm>
            <a:off x="9187592" y="46864"/>
            <a:ext cx="2994433" cy="6649826"/>
            <a:chOff x="9187592" y="87120"/>
            <a:chExt cx="2994433" cy="6649826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41612CC-2831-4E66-A9E4-308CD8DD433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346675" y="2753512"/>
              <a:ext cx="1800225" cy="18669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1A3BF35-CB2E-4511-91C5-7A25DDF355BB}"/>
                </a:ext>
              </a:extLst>
            </p:cNvPr>
            <p:cNvSpPr txBox="1"/>
            <p:nvPr/>
          </p:nvSpPr>
          <p:spPr>
            <a:xfrm>
              <a:off x="9630707" y="4566369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5.128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360C993-CB7E-41F3-B38C-010380F35924}"/>
                </a:ext>
              </a:extLst>
            </p:cNvPr>
            <p:cNvSpPr txBox="1"/>
            <p:nvPr/>
          </p:nvSpPr>
          <p:spPr>
            <a:xfrm>
              <a:off x="10986544" y="4584366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27.1179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41C9746-2C16-4253-87D0-F54E35B99413}"/>
                </a:ext>
              </a:extLst>
            </p:cNvPr>
            <p:cNvSpPr txBox="1"/>
            <p:nvPr/>
          </p:nvSpPr>
          <p:spPr>
            <a:xfrm>
              <a:off x="10534626" y="4741910"/>
              <a:ext cx="676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/>
                <a:t>− H</a:t>
              </a:r>
              <a:r>
                <a:rPr lang="sv-SE" sz="1200" baseline="-25000" dirty="0"/>
                <a:t>2</a:t>
              </a:r>
              <a:r>
                <a:rPr lang="sv-SE" sz="1200" dirty="0"/>
                <a:t>O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3D308316-E8B9-47A2-96E3-C237153BAAC4}"/>
                </a:ext>
              </a:extLst>
            </p:cNvPr>
            <p:cNvCxnSpPr/>
            <p:nvPr/>
          </p:nvCxnSpPr>
          <p:spPr>
            <a:xfrm>
              <a:off x="10699130" y="4741910"/>
              <a:ext cx="17360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BA48AD6-CBB2-AA17-5C24-59132E1F8D6F}"/>
                </a:ext>
              </a:extLst>
            </p:cNvPr>
            <p:cNvSpPr txBox="1"/>
            <p:nvPr/>
          </p:nvSpPr>
          <p:spPr>
            <a:xfrm>
              <a:off x="10427061" y="6398392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7479302-79C4-48ED-C35B-E6C48E4393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2984" b="47596"/>
            <a:stretch/>
          </p:blipFill>
          <p:spPr>
            <a:xfrm>
              <a:off x="10463942" y="5350160"/>
              <a:ext cx="1102458" cy="1182971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985CD6A-740A-4D49-8CE4-8E802F832A8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187592" y="87120"/>
              <a:ext cx="2552700" cy="228600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AD23D54-1B8F-4245-A901-D798EF194FCD}"/>
                </a:ext>
              </a:extLst>
            </p:cNvPr>
            <p:cNvSpPr txBox="1"/>
            <p:nvPr/>
          </p:nvSpPr>
          <p:spPr>
            <a:xfrm>
              <a:off x="10826188" y="2268171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511.271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692245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D69F6-9A88-4392-AE0F-3AC5020182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3, Mono-hydroxylation + glucuronidation (indazole ring), </a:t>
            </a:r>
            <a:br>
              <a:rPr lang="en-GB" sz="2800" dirty="0"/>
            </a:br>
            <a:r>
              <a:rPr lang="en-GB" sz="2800" dirty="0"/>
              <a:t>RT 5.71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855A9538-160A-4FAF-8E5E-89079ACAEC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74" y="1690688"/>
            <a:ext cx="9247695" cy="2549082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63837661-80B1-43CB-AF87-6FBF80A7F3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874" y="4315242"/>
            <a:ext cx="9247695" cy="2421045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F85CA21C-4DFF-506D-8666-03A716BE7A04}"/>
              </a:ext>
            </a:extLst>
          </p:cNvPr>
          <p:cNvGrpSpPr/>
          <p:nvPr/>
        </p:nvGrpSpPr>
        <p:grpSpPr>
          <a:xfrm>
            <a:off x="9278569" y="214691"/>
            <a:ext cx="3120605" cy="6379644"/>
            <a:chOff x="9278569" y="185194"/>
            <a:chExt cx="3120605" cy="6379644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9536A35-19B8-4DE9-9471-9869EDCAD53D}"/>
                </a:ext>
              </a:extLst>
            </p:cNvPr>
            <p:cNvSpPr txBox="1"/>
            <p:nvPr/>
          </p:nvSpPr>
          <p:spPr>
            <a:xfrm>
              <a:off x="11203693" y="5955771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61.0346</a:t>
              </a:r>
            </a:p>
          </p:txBody>
        </p: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845C2C56-546E-49C6-BE6F-653495CC5C4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904866" y="4881025"/>
              <a:ext cx="1085850" cy="1133475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C885715D-66FE-4DA6-B52E-9526A7A31B3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857581" y="2554813"/>
              <a:ext cx="2295525" cy="2028825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1CD542B-C724-4179-A444-AE77AE16C17D}"/>
                </a:ext>
              </a:extLst>
            </p:cNvPr>
            <p:cNvSpPr txBox="1"/>
            <p:nvPr/>
          </p:nvSpPr>
          <p:spPr>
            <a:xfrm>
              <a:off x="10965645" y="4278844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421.1605</a:t>
              </a:r>
            </a:p>
          </p:txBody>
        </p: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4EA437CE-F145-4B12-8BBB-1C87977E593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278569" y="4755088"/>
              <a:ext cx="1857375" cy="1809750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D32D66C-7C83-4389-8AB3-C89C0D191AC1}"/>
                </a:ext>
              </a:extLst>
            </p:cNvPr>
            <p:cNvSpPr txBox="1"/>
            <p:nvPr/>
          </p:nvSpPr>
          <p:spPr>
            <a:xfrm>
              <a:off x="9466456" y="6018684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5.1284</a:t>
              </a:r>
            </a:p>
          </p:txBody>
        </p:sp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09F3AAC2-6502-3B77-2535-AEFC8A9A33B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73883331"/>
                </p:ext>
              </p:extLst>
            </p:nvPr>
          </p:nvGraphicFramePr>
          <p:xfrm>
            <a:off x="9569737" y="185194"/>
            <a:ext cx="2184400" cy="2316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hemSketch" r:id="rId7" imgW="2184840" imgH="2315880" progId="ACD.ChemSketch.20">
                    <p:embed/>
                  </p:oleObj>
                </mc:Choice>
                <mc:Fallback>
                  <p:oleObj name="ChemSketch" r:id="rId7" imgW="2184840" imgH="2315880" progId="ACD.ChemSketch.20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09F3AAC2-6502-3B77-2535-AEFC8A9A33B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9569737" y="185194"/>
                          <a:ext cx="2184400" cy="23161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8813A9F-E97B-4972-8263-CEBA288409AA}"/>
                </a:ext>
              </a:extLst>
            </p:cNvPr>
            <p:cNvSpPr txBox="1"/>
            <p:nvPr/>
          </p:nvSpPr>
          <p:spPr>
            <a:xfrm>
              <a:off x="11005343" y="1027906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511.271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098637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4A4B6-4D71-4CE9-A2D3-4469699558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4, Dihydrodiol, RT 6.16 mi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5ED1EAE-02FD-4863-9674-0D12798129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583703"/>
            <a:ext cx="9738149" cy="276394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34B67E9-7C89-43E8-AEA5-52E76F76C8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347646"/>
            <a:ext cx="9898145" cy="251035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D042D4F7-2A11-137D-663D-20A26CB90FAC}"/>
              </a:ext>
            </a:extLst>
          </p:cNvPr>
          <p:cNvGrpSpPr/>
          <p:nvPr/>
        </p:nvGrpSpPr>
        <p:grpSpPr>
          <a:xfrm>
            <a:off x="9751137" y="16325"/>
            <a:ext cx="2316780" cy="6400508"/>
            <a:chOff x="9751137" y="16325"/>
            <a:chExt cx="2316780" cy="6400508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04E6AC2-0B94-49CB-AE4D-7A38BB2945F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058142" y="2560647"/>
              <a:ext cx="2009775" cy="180975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E518CF0-90FF-416D-98DC-B8802FC0207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751137" y="16325"/>
              <a:ext cx="2028825" cy="222885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0D5EB55-1A31-4D7C-A359-4DE122A913EB}"/>
                </a:ext>
              </a:extLst>
            </p:cNvPr>
            <p:cNvSpPr txBox="1"/>
            <p:nvPr/>
          </p:nvSpPr>
          <p:spPr>
            <a:xfrm>
              <a:off x="10058142" y="3597238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63.1390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B06EFA8-189E-4F4A-A606-DAFA3284076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294642" y="4363468"/>
              <a:ext cx="1238250" cy="1133475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639A60B-45A1-4C95-8123-FE7A39937B40}"/>
                </a:ext>
              </a:extLst>
            </p:cNvPr>
            <p:cNvSpPr txBox="1"/>
            <p:nvPr/>
          </p:nvSpPr>
          <p:spPr>
            <a:xfrm>
              <a:off x="10442774" y="5422933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79.045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6408DDB-1D68-4220-B588-5EFAA9047FED}"/>
                </a:ext>
              </a:extLst>
            </p:cNvPr>
            <p:cNvSpPr txBox="1"/>
            <p:nvPr/>
          </p:nvSpPr>
          <p:spPr>
            <a:xfrm>
              <a:off x="10442774" y="6078279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61.0346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1A1992C6-4632-40DB-84CD-84FA22C07647}"/>
                </a:ext>
              </a:extLst>
            </p:cNvPr>
            <p:cNvCxnSpPr>
              <a:cxnSpLocks/>
            </p:cNvCxnSpPr>
            <p:nvPr/>
          </p:nvCxnSpPr>
          <p:spPr>
            <a:xfrm>
              <a:off x="10901563" y="5792265"/>
              <a:ext cx="0" cy="2799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0A89D57-A565-4BD7-B4F1-9C46C6EB9526}"/>
                </a:ext>
              </a:extLst>
            </p:cNvPr>
            <p:cNvSpPr txBox="1"/>
            <p:nvPr/>
          </p:nvSpPr>
          <p:spPr>
            <a:xfrm>
              <a:off x="10929455" y="5788342"/>
              <a:ext cx="676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/>
                <a:t>− H</a:t>
              </a:r>
              <a:r>
                <a:rPr lang="sv-SE" sz="1200" baseline="-25000" dirty="0"/>
                <a:t>2</a:t>
              </a:r>
              <a:r>
                <a:rPr lang="sv-SE" sz="1200" dirty="0"/>
                <a:t>O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EBB4945-F3E4-4E05-BD7E-9D7BBD75916D}"/>
                </a:ext>
              </a:extLst>
            </p:cNvPr>
            <p:cNvSpPr txBox="1"/>
            <p:nvPr/>
          </p:nvSpPr>
          <p:spPr>
            <a:xfrm>
              <a:off x="9751137" y="1525715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93.249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956952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42B03A-11B3-42DA-A99D-ACC4C035B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dirty="0"/>
              <a:t>M5, </a:t>
            </a:r>
            <a:r>
              <a:rPr lang="en-GB" sz="2800"/>
              <a:t>Carboxylic acid formation </a:t>
            </a:r>
            <a:r>
              <a:rPr lang="en-GB" sz="2800" dirty="0"/>
              <a:t>(hexanoic acid),</a:t>
            </a:r>
            <a:br>
              <a:rPr lang="en-GB" sz="2800" dirty="0"/>
            </a:br>
            <a:r>
              <a:rPr lang="en-GB" sz="2800" dirty="0"/>
              <a:t>RT 6.31 mi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C72E702-93D7-4143-A49F-974D00CE76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268" y="1461154"/>
            <a:ext cx="9342604" cy="26516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66F2C5F-68BC-4CC5-8407-9A77E2FA28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268" y="4287910"/>
            <a:ext cx="9436872" cy="247057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B7DD8F0-373E-4732-A55A-DBE893E32415}"/>
              </a:ext>
            </a:extLst>
          </p:cNvPr>
          <p:cNvSpPr txBox="1"/>
          <p:nvPr/>
        </p:nvSpPr>
        <p:spPr>
          <a:xfrm>
            <a:off x="4312859" y="5322402"/>
            <a:ext cx="10627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00" dirty="0">
                <a:solidFill>
                  <a:srgbClr val="6060E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1.1110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E0A1EB1-2A1E-86B2-0788-EB5DD3CD1FFB}"/>
              </a:ext>
            </a:extLst>
          </p:cNvPr>
          <p:cNvGrpSpPr/>
          <p:nvPr/>
        </p:nvGrpSpPr>
        <p:grpSpPr>
          <a:xfrm>
            <a:off x="7337423" y="222842"/>
            <a:ext cx="4994442" cy="6474200"/>
            <a:chOff x="7337423" y="222842"/>
            <a:chExt cx="4994442" cy="6474200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90061EA-E5C7-4209-B336-D533F9F27A26}"/>
                </a:ext>
              </a:extLst>
            </p:cNvPr>
            <p:cNvSpPr txBox="1"/>
            <p:nvPr/>
          </p:nvSpPr>
          <p:spPr>
            <a:xfrm>
              <a:off x="11136384" y="6104568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DC0E7941-0C55-401D-86D3-B5CC6075535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707887" y="3307087"/>
              <a:ext cx="1552575" cy="1819275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832CAB6-3BE8-4AFC-B8E4-A6E78A30489B}"/>
                </a:ext>
              </a:extLst>
            </p:cNvPr>
            <p:cNvSpPr txBox="1"/>
            <p:nvPr/>
          </p:nvSpPr>
          <p:spPr>
            <a:xfrm>
              <a:off x="9609655" y="4399244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13.1022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BDFAD0FE-D6BD-41C7-A180-0C506BC0C89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513999" y="5249242"/>
              <a:ext cx="1552575" cy="1447800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AE56E35-1C1B-43FB-BBC9-9CCA5E747A5B}"/>
                </a:ext>
              </a:extLst>
            </p:cNvPr>
            <p:cNvSpPr txBox="1"/>
            <p:nvPr/>
          </p:nvSpPr>
          <p:spPr>
            <a:xfrm>
              <a:off x="9531140" y="6027199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85.1073</a:t>
              </a:r>
            </a:p>
          </p:txBody>
        </p: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B543A237-9B0B-47E6-9985-A648194578A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383086" y="4538435"/>
              <a:ext cx="1971675" cy="1752600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49B24E0-3C31-4713-A56C-53374500D77C}"/>
                </a:ext>
              </a:extLst>
            </p:cNvPr>
            <p:cNvSpPr txBox="1"/>
            <p:nvPr/>
          </p:nvSpPr>
          <p:spPr>
            <a:xfrm>
              <a:off x="7430709" y="5414735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31.1128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691784F1-E469-4098-9CA7-E0C84BC5B0C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430709" y="1613644"/>
              <a:ext cx="1876425" cy="2114550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F1DE358-B589-4524-A3E3-E33CF13ED293}"/>
                </a:ext>
              </a:extLst>
            </p:cNvPr>
            <p:cNvSpPr txBox="1"/>
            <p:nvPr/>
          </p:nvSpPr>
          <p:spPr>
            <a:xfrm>
              <a:off x="7337423" y="2786717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1.0972</a:t>
              </a:r>
            </a:p>
          </p:txBody>
        </p:sp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DF5185FE-A57B-6A60-E746-8E1FEEE703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44113571"/>
                </p:ext>
              </p:extLst>
            </p:nvPr>
          </p:nvGraphicFramePr>
          <p:xfrm>
            <a:off x="9609655" y="222842"/>
            <a:ext cx="1876425" cy="23971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hemSketch" r:id="rId8" imgW="1876680" imgH="2397600" progId="ACD.ChemSketch.20">
                    <p:embed/>
                  </p:oleObj>
                </mc:Choice>
                <mc:Fallback>
                  <p:oleObj name="ChemSketch" r:id="rId8" imgW="1876680" imgH="2397600" progId="ACD.ChemSketch.20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DF5185FE-A57B-6A60-E746-8E1FEEE703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9609655" y="222842"/>
                          <a:ext cx="1876425" cy="23971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DAFECF5F-CDB7-4530-AAF4-7A71A3C019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r="42984" b="47596"/>
            <a:stretch/>
          </p:blipFill>
          <p:spPr>
            <a:xfrm>
              <a:off x="11066574" y="5078252"/>
              <a:ext cx="1102458" cy="1182971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F462668-5203-4D08-8E55-716C7165BABB}"/>
                </a:ext>
              </a:extLst>
            </p:cNvPr>
            <p:cNvSpPr txBox="1"/>
            <p:nvPr/>
          </p:nvSpPr>
          <p:spPr>
            <a:xfrm>
              <a:off x="10726621" y="1150695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89.218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544617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E3A63-AE8A-02C2-32C3-F53353BB0B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5373" y="325979"/>
            <a:ext cx="10515600" cy="1325563"/>
          </a:xfrm>
        </p:spPr>
        <p:txBody>
          <a:bodyPr>
            <a:normAutofit/>
          </a:bodyPr>
          <a:lstStyle/>
          <a:p>
            <a:r>
              <a:rPr lang="sv-SE" sz="2800" dirty="0"/>
              <a:t>M6/M7, Mono-hydroxylation </a:t>
            </a:r>
            <a:br>
              <a:rPr lang="sv-SE" sz="2800" dirty="0"/>
            </a:br>
            <a:r>
              <a:rPr lang="sv-SE" sz="2800" dirty="0"/>
              <a:t>(5-hydroxy-hexyl/6-hydroxy-hexyl), RT 6.48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221AB2D7-47D4-421E-A4F6-A7FEB683B3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726" y="4418995"/>
            <a:ext cx="8957634" cy="233947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993B240-0DA0-4EC1-AF15-301FCE83E1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1771" y="1690688"/>
            <a:ext cx="9029405" cy="249459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346560E-D092-4491-93FA-8ABEF195D8E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63478"/>
          <a:stretch/>
        </p:blipFill>
        <p:spPr>
          <a:xfrm>
            <a:off x="5996699" y="1734800"/>
            <a:ext cx="2915190" cy="216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A9C39691-8B30-4018-9448-9D38AEB11F8C}"/>
              </a:ext>
            </a:extLst>
          </p:cNvPr>
          <p:cNvSpPr txBox="1"/>
          <p:nvPr/>
        </p:nvSpPr>
        <p:spPr>
          <a:xfrm>
            <a:off x="7831942" y="2177553"/>
            <a:ext cx="6203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FF36C7D-F93B-46F2-93F6-EAE22F85A50C}"/>
              </a:ext>
            </a:extLst>
          </p:cNvPr>
          <p:cNvSpPr txBox="1"/>
          <p:nvPr/>
        </p:nvSpPr>
        <p:spPr>
          <a:xfrm>
            <a:off x="8142113" y="2957038"/>
            <a:ext cx="4985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7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FAB6833-AC4A-A2AE-C2B4-3E2D102326C8}"/>
              </a:ext>
            </a:extLst>
          </p:cNvPr>
          <p:cNvGrpSpPr/>
          <p:nvPr/>
        </p:nvGrpSpPr>
        <p:grpSpPr>
          <a:xfrm>
            <a:off x="6899214" y="285722"/>
            <a:ext cx="5476545" cy="6314215"/>
            <a:chOff x="6899214" y="285722"/>
            <a:chExt cx="5476545" cy="6314215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9A4ED96-8846-9C9F-3BDC-E45F17E93FCF}"/>
                </a:ext>
              </a:extLst>
            </p:cNvPr>
            <p:cNvSpPr txBox="1"/>
            <p:nvPr/>
          </p:nvSpPr>
          <p:spPr>
            <a:xfrm>
              <a:off x="10842172" y="4006524"/>
              <a:ext cx="676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/>
                <a:t>− H</a:t>
              </a:r>
              <a:r>
                <a:rPr lang="sv-SE" sz="1200" baseline="-25000" dirty="0"/>
                <a:t>2</a:t>
              </a:r>
              <a:r>
                <a:rPr lang="sv-SE" sz="1200" dirty="0"/>
                <a:t>O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A4DE9DC-1A84-6877-8CE9-AF0D56741442}"/>
                </a:ext>
              </a:extLst>
            </p:cNvPr>
            <p:cNvSpPr txBox="1"/>
            <p:nvPr/>
          </p:nvSpPr>
          <p:spPr>
            <a:xfrm>
              <a:off x="9950786" y="3791458"/>
              <a:ext cx="10649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5.128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36AF651-0B6E-EB29-2231-4EA2ED59110F}"/>
                </a:ext>
              </a:extLst>
            </p:cNvPr>
            <p:cNvSpPr txBox="1"/>
            <p:nvPr/>
          </p:nvSpPr>
          <p:spPr>
            <a:xfrm>
              <a:off x="11180278" y="3775692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27.1179</a:t>
              </a: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299B2470-E272-45D0-BDA1-5CC4349E3B25}"/>
                </a:ext>
              </a:extLst>
            </p:cNvPr>
            <p:cNvCxnSpPr>
              <a:cxnSpLocks/>
            </p:cNvCxnSpPr>
            <p:nvPr/>
          </p:nvCxnSpPr>
          <p:spPr>
            <a:xfrm>
              <a:off x="11006676" y="3960735"/>
              <a:ext cx="17360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0B72D00-FA62-43F5-ACDB-D84776692E87}"/>
                </a:ext>
              </a:extLst>
            </p:cNvPr>
            <p:cNvSpPr txBox="1"/>
            <p:nvPr/>
          </p:nvSpPr>
          <p:spPr>
            <a:xfrm>
              <a:off x="10158319" y="6261383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8249892-3D52-177D-679D-344E54943679}"/>
                </a:ext>
              </a:extLst>
            </p:cNvPr>
            <p:cNvSpPr txBox="1"/>
            <p:nvPr/>
          </p:nvSpPr>
          <p:spPr>
            <a:xfrm>
              <a:off x="6899214" y="285722"/>
              <a:ext cx="3488758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M6) 5-OH (major)</a:t>
              </a:r>
            </a:p>
            <a:p>
              <a:pPr algn="ctr"/>
              <a:r>
                <a:rPr lang="sv-SE" sz="1600" dirty="0"/>
                <a:t>M7) 6-OH (minor)</a:t>
              </a:r>
            </a:p>
            <a:p>
              <a:pPr algn="ctr"/>
              <a:r>
                <a:rPr lang="sv-SE" sz="1600" dirty="0"/>
                <a:t>Not baseline separated. Confirmed with synthesized standards.</a:t>
              </a:r>
            </a:p>
          </p:txBody>
        </p:sp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52F98BFA-0D1C-E2DE-385D-22E8B52ED7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0672570"/>
                </p:ext>
              </p:extLst>
            </p:nvPr>
          </p:nvGraphicFramePr>
          <p:xfrm>
            <a:off x="10015075" y="421754"/>
            <a:ext cx="1753937" cy="244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hemSketch" r:id="rId5" imgW="1704240" imgH="2379240" progId="ACD.ChemSketch.20">
                    <p:embed/>
                  </p:oleObj>
                </mc:Choice>
                <mc:Fallback>
                  <p:oleObj name="ChemSketch" r:id="rId5" imgW="1704240" imgH="2379240" progId="ACD.ChemSketch.20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52F98BFA-0D1C-E2DE-385D-22E8B52ED72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0015075" y="421754"/>
                          <a:ext cx="1753937" cy="244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D00687FB-B02A-4606-A54D-1F4A004935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42984" b="47596"/>
            <a:stretch/>
          </p:blipFill>
          <p:spPr>
            <a:xfrm>
              <a:off x="10166018" y="5190434"/>
              <a:ext cx="1102458" cy="118297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86F34BE-17DD-4B22-A7A2-551A5CBC3B6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041947" y="2996725"/>
              <a:ext cx="1800225" cy="209550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A75BAF1-CE71-4EEF-8732-7521EC53A3FB}"/>
                </a:ext>
              </a:extLst>
            </p:cNvPr>
            <p:cNvSpPr txBox="1"/>
            <p:nvPr/>
          </p:nvSpPr>
          <p:spPr>
            <a:xfrm>
              <a:off x="9825605" y="1864857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5.239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613499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974F16C5-1657-5EBF-54D1-59C3F2861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365125"/>
            <a:ext cx="8351339" cy="1325563"/>
          </a:xfrm>
        </p:spPr>
        <p:txBody>
          <a:bodyPr>
            <a:normAutofit/>
          </a:bodyPr>
          <a:lstStyle/>
          <a:p>
            <a:r>
              <a:rPr lang="sv-SE" sz="2800" dirty="0"/>
              <a:t>M8, Mono-hydroxylation (4-hydroxy-hexyl), RT 6.68 min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836D649-7BEE-76F2-D281-B2EF7FE028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9293"/>
            <a:ext cx="9064499" cy="258687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F12F8BF-D810-29ED-F21C-24073EF635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1697" y="4331174"/>
            <a:ext cx="9211236" cy="2526826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5C5993C8-367C-C805-B0DA-08053F430E90}"/>
              </a:ext>
            </a:extLst>
          </p:cNvPr>
          <p:cNvGrpSpPr/>
          <p:nvPr/>
        </p:nvGrpSpPr>
        <p:grpSpPr>
          <a:xfrm>
            <a:off x="9064499" y="99001"/>
            <a:ext cx="3210159" cy="6367061"/>
            <a:chOff x="9064499" y="139257"/>
            <a:chExt cx="3210159" cy="6367061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7F41C54-B8F8-F116-772B-121E702B014C}"/>
                </a:ext>
              </a:extLst>
            </p:cNvPr>
            <p:cNvSpPr txBox="1"/>
            <p:nvPr/>
          </p:nvSpPr>
          <p:spPr>
            <a:xfrm>
              <a:off x="9604619" y="4222038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45.128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A97022E-BEB3-50E9-6874-145FAAE90111}"/>
                </a:ext>
              </a:extLst>
            </p:cNvPr>
            <p:cNvSpPr txBox="1"/>
            <p:nvPr/>
          </p:nvSpPr>
          <p:spPr>
            <a:xfrm>
              <a:off x="11025430" y="4222038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227.1179</a:t>
              </a: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975E5A1C-C016-1D8D-FF00-42FB553C1790}"/>
                </a:ext>
              </a:extLst>
            </p:cNvPr>
            <p:cNvCxnSpPr>
              <a:stCxn id="13" idx="3"/>
            </p:cNvCxnSpPr>
            <p:nvPr/>
          </p:nvCxnSpPr>
          <p:spPr>
            <a:xfrm>
              <a:off x="10800100" y="4391315"/>
              <a:ext cx="173602" cy="1538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F2A90EA-160D-B3C3-90EB-23EF362B5905}"/>
                </a:ext>
              </a:extLst>
            </p:cNvPr>
            <p:cNvSpPr txBox="1"/>
            <p:nvPr/>
          </p:nvSpPr>
          <p:spPr>
            <a:xfrm>
              <a:off x="10586182" y="4442584"/>
              <a:ext cx="6762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/>
                <a:t>− H</a:t>
              </a:r>
              <a:r>
                <a:rPr lang="sv-SE" sz="1200" baseline="-25000" dirty="0"/>
                <a:t>2</a:t>
              </a:r>
              <a:r>
                <a:rPr lang="sv-SE" sz="1200" dirty="0"/>
                <a:t>O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5A4DC54-C466-8FBF-7998-490A2A8194BC}"/>
                </a:ext>
              </a:extLst>
            </p:cNvPr>
            <p:cNvSpPr txBox="1"/>
            <p:nvPr/>
          </p:nvSpPr>
          <p:spPr>
            <a:xfrm>
              <a:off x="10273811" y="6167764"/>
              <a:ext cx="119548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145.0396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ECB3C7A-14AA-4288-894C-08481E3BD2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42984" b="47596"/>
            <a:stretch/>
          </p:blipFill>
          <p:spPr>
            <a:xfrm>
              <a:off x="10335672" y="5114117"/>
              <a:ext cx="1102458" cy="1182971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59CC4A7-BDDD-4B4B-B593-B3681728CBEE}"/>
                </a:ext>
              </a:extLst>
            </p:cNvPr>
            <p:cNvSpPr txBox="1"/>
            <p:nvPr/>
          </p:nvSpPr>
          <p:spPr>
            <a:xfrm>
              <a:off x="10871551" y="297846"/>
              <a:ext cx="11954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[M+H]</a:t>
              </a:r>
              <a:r>
                <a:rPr lang="sv-SE" sz="1600" baseline="30000" dirty="0"/>
                <a:t>+</a:t>
              </a:r>
            </a:p>
            <a:p>
              <a:pPr algn="ctr"/>
              <a:r>
                <a:rPr lang="sv-SE" sz="1600" dirty="0"/>
                <a:t>375.2391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12ED95E-FFC9-D919-2614-23B2CE09A2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47396" b="47317"/>
            <a:stretch/>
          </p:blipFill>
          <p:spPr>
            <a:xfrm>
              <a:off x="9064499" y="139257"/>
              <a:ext cx="1858903" cy="234342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FE0BFFE-E68F-D029-0C47-0EA3E8761D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48676" b="48657"/>
            <a:stretch/>
          </p:blipFill>
          <p:spPr>
            <a:xfrm>
              <a:off x="9064499" y="2442982"/>
              <a:ext cx="1784321" cy="1853449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761849E-70B0-E245-8A73-C93A317BB68A}"/>
                </a:ext>
              </a:extLst>
            </p:cNvPr>
            <p:cNvSpPr txBox="1"/>
            <p:nvPr/>
          </p:nvSpPr>
          <p:spPr>
            <a:xfrm>
              <a:off x="10432944" y="1005259"/>
              <a:ext cx="184171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/>
                <a:t>Confirmed with synthesized standard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16346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0CB91D04B636742A7416A8009D116AD" ma:contentTypeVersion="7" ma:contentTypeDescription="Create a new document." ma:contentTypeScope="" ma:versionID="4c45b0062feeb7de8b5f3ac5e3abda2d">
  <xsd:schema xmlns:xsd="http://www.w3.org/2001/XMLSchema" xmlns:xs="http://www.w3.org/2001/XMLSchema" xmlns:p="http://schemas.microsoft.com/office/2006/metadata/properties" xmlns:ns3="9072c07f-0bb9-4467-9531-632750e01900" xmlns:ns4="003cfbf7-78ee-41ca-9f52-481dfbe3b0cc" targetNamespace="http://schemas.microsoft.com/office/2006/metadata/properties" ma:root="true" ma:fieldsID="5912a78af29db11a9015623bfc8cb7d4" ns3:_="" ns4:_="">
    <xsd:import namespace="9072c07f-0bb9-4467-9531-632750e01900"/>
    <xsd:import namespace="003cfbf7-78ee-41ca-9f52-481dfbe3b0c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072c07f-0bb9-4467-9531-632750e0190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03cfbf7-78ee-41ca-9f52-481dfbe3b0c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2BE53C2-AAA2-4049-8B6F-659D79255DD6}">
  <ds:schemaRefs>
    <ds:schemaRef ds:uri="http://www.w3.org/XML/1998/namespace"/>
    <ds:schemaRef ds:uri="http://purl.org/dc/elements/1.1/"/>
    <ds:schemaRef ds:uri="http://schemas.openxmlformats.org/package/2006/metadata/core-properties"/>
    <ds:schemaRef ds:uri="http://purl.org/dc/terms/"/>
    <ds:schemaRef ds:uri="http://schemas.microsoft.com/office/2006/documentManagement/types"/>
    <ds:schemaRef ds:uri="http://purl.org/dc/dcmitype/"/>
    <ds:schemaRef ds:uri="003cfbf7-78ee-41ca-9f52-481dfbe3b0cc"/>
    <ds:schemaRef ds:uri="http://schemas.microsoft.com/office/infopath/2007/PartnerControls"/>
    <ds:schemaRef ds:uri="9072c07f-0bb9-4467-9531-632750e01900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AEC4BB63-4440-435A-9E0C-C003DC2C380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072c07f-0bb9-4467-9531-632750e01900"/>
    <ds:schemaRef ds:uri="003cfbf7-78ee-41ca-9f52-481dfbe3b0c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78C9808-0C3C-4799-B570-6A7EAF3EC11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4</Words>
  <Application>Microsoft Office PowerPoint</Application>
  <PresentationFormat>Widescreen</PresentationFormat>
  <Paragraphs>124</Paragraphs>
  <Slides>1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ChemSketch</vt:lpstr>
      <vt:lpstr>PowerPoint Presentation</vt:lpstr>
      <vt:lpstr>ADB-HEXINACA, RT 10.30 min</vt:lpstr>
      <vt:lpstr>M1, Di-hydroxylation (hexyl tail + tert-butyl), RT 5.21 min</vt:lpstr>
      <vt:lpstr>M2, Mono-hydroxylation + glucuronidation (hexyl tail),  RT 5.21 min</vt:lpstr>
      <vt:lpstr>M3, Mono-hydroxylation + glucuronidation (indazole ring),  RT 5.71</vt:lpstr>
      <vt:lpstr>M4, Dihydrodiol, RT 6.16 min</vt:lpstr>
      <vt:lpstr>M5, Carboxylic acid formation (hexanoic acid), RT 6.31 min</vt:lpstr>
      <vt:lpstr>M6/M7, Mono-hydroxylation  (5-hydroxy-hexyl/6-hydroxy-hexyl), RT 6.48</vt:lpstr>
      <vt:lpstr>M8, Mono-hydroxylation (4-hydroxy-hexyl), RT 6.68 min</vt:lpstr>
      <vt:lpstr>M9, Ketone formation (5-oxo-hexyl), RT 6.75 min</vt:lpstr>
      <vt:lpstr>M10, Mono-hydroxylation (hexyl tail), RT 7.07</vt:lpstr>
      <vt:lpstr>M11, Ketone formation (4-oxo-hexyl), RT 7.20</vt:lpstr>
      <vt:lpstr>M12, Ketone formation (hexyl tail), RT 7.61 min</vt:lpstr>
      <vt:lpstr>M13, Terminal amide hydrolysis + ketone formation  (5-oxo-hexyl), RT 7.67</vt:lpstr>
      <vt:lpstr>M14, Mono-hydroxylation (indazole ring), RT 8.23</vt:lpstr>
      <vt:lpstr>M15, Mono-hydroxylation (tert-butyl), RT 8.61</vt:lpstr>
      <vt:lpstr>M16, Terminal amide hydrolysis, RT 11.12 mi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B-HEXINACA</dc:title>
  <dc:creator>Henrik Green</dc:creator>
  <cp:lastModifiedBy>Steven Baginski (PG Research)</cp:lastModifiedBy>
  <cp:revision>14</cp:revision>
  <dcterms:created xsi:type="dcterms:W3CDTF">2022-09-30T12:08:15Z</dcterms:created>
  <dcterms:modified xsi:type="dcterms:W3CDTF">2023-07-04T14:44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0CB91D04B636742A7416A8009D116AD</vt:lpwstr>
  </property>
</Properties>
</file>